
<file path=[Content_Types].xml><?xml version="1.0" encoding="utf-8"?>
<Types xmlns="http://schemas.openxmlformats.org/package/2006/content-types">
  <Default Extension="bin" ContentType="application/vnd.openxmlformats-officedocument.oleObject"/>
  <Default Extension="rels" ContentType="application/vnd.openxmlformats-package.relationships+xml"/>
  <Default Extension="xml" ContentType="application/xml"/>
  <Default Extension="tiff" ContentType="image/tiff"/>
  <Default Extension="xlsx" ContentType="application/vnd.openxmlformats-officedocument.spreadsheetml.sheet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5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0B0B0"/>
    <a:srgbClr val="5F5F5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88" d="100"/>
          <a:sy n="88" d="100"/>
        </p:scale>
        <p:origin x="576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Tutto%20lavoro\Lavori\Lav%20IPO7\New%20Submission2018\submission%20revision\Dati%20Simona\miRs%20CUrcu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Tutto%20lavoro\Lavori\Lav%20IPO7\New%20Submission2018\submission%20revision\Dati%20Simona\HIF1a%20lama%20k562%2022-9.xls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Fontana\AppData\Roaming\Microsoft\Excel\Densitometria%20IPO7-ACTB%20(version%201).xlsb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miRs CUrcu.xlsx]miR-22'!$A$14</c:f>
              <c:strCache>
                <c:ptCount val="1"/>
                <c:pt idx="0">
                  <c:v>Ctrl</c:v>
                </c:pt>
              </c:strCache>
            </c:strRef>
          </c:tx>
          <c:spPr>
            <a:solidFill>
              <a:srgbClr val="4B4B4B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[miRs CUrcu.xlsx]miR-22'!$B$13</c:f>
              <c:strCache>
                <c:ptCount val="1"/>
                <c:pt idx="0">
                  <c:v>fold</c:v>
                </c:pt>
              </c:strCache>
            </c:strRef>
          </c:cat>
          <c:val>
            <c:numRef>
              <c:f>'[miRs CUrcu.xlsx]miR-22'!$B$14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</c:ser>
        <c:ser>
          <c:idx val="1"/>
          <c:order val="1"/>
          <c:tx>
            <c:strRef>
              <c:f>'[miRs CUrcu.xlsx]miR-22'!$A$15</c:f>
              <c:strCache>
                <c:ptCount val="1"/>
                <c:pt idx="0">
                  <c:v>Curcu 20 µM</c:v>
                </c:pt>
              </c:strCache>
            </c:strRef>
          </c:tx>
          <c:spPr>
            <a:solidFill>
              <a:srgbClr val="B0B0B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[miRs CUrcu.xlsx]miR-22'!$B$13</c:f>
              <c:strCache>
                <c:ptCount val="1"/>
                <c:pt idx="0">
                  <c:v>fold</c:v>
                </c:pt>
              </c:strCache>
            </c:strRef>
          </c:cat>
          <c:val>
            <c:numRef>
              <c:f>'[miRs CUrcu.xlsx]miR-22'!$B$15</c:f>
              <c:numCache>
                <c:formatCode>General</c:formatCode>
                <c:ptCount val="1"/>
                <c:pt idx="0">
                  <c:v>6.351952343593008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38191216"/>
        <c:axId val="738188472"/>
      </c:barChart>
      <c:catAx>
        <c:axId val="7381912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738188472"/>
        <c:crosses val="autoZero"/>
        <c:auto val="1"/>
        <c:lblAlgn val="ctr"/>
        <c:lblOffset val="100"/>
        <c:noMultiLvlLbl val="0"/>
      </c:catAx>
      <c:valAx>
        <c:axId val="7381884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it-IT" sz="1000" b="0" i="0" baseline="0">
                    <a:effectLst/>
                  </a:rPr>
                  <a:t>FOI miR-22 expression </a:t>
                </a:r>
                <a:endParaRPr lang="it-IT" sz="1000" b="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it-IT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7381912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it-IT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Real Time IPO7.xlsx]Riepilogo'!$A$2</c:f>
              <c:strCache>
                <c:ptCount val="1"/>
                <c:pt idx="0">
                  <c:v>Ctrl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val>
            <c:numRef>
              <c:f>'[Real Time IPO7.xlsx]Riepilogo'!$D$2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</c:ser>
        <c:ser>
          <c:idx val="1"/>
          <c:order val="1"/>
          <c:tx>
            <c:strRef>
              <c:f>'[Real Time IPO7.xlsx]Riepilogo'!$A$3</c:f>
              <c:strCache>
                <c:ptCount val="1"/>
                <c:pt idx="0">
                  <c:v>Curcumin 20 µM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Real Time IPO7.xlsx]Riepilogo'!$E$3</c:f>
                <c:numCache>
                  <c:formatCode>General</c:formatCode>
                  <c:ptCount val="1"/>
                  <c:pt idx="0">
                    <c:v>6.8078379100094816E-2</c:v>
                  </c:pt>
                </c:numCache>
              </c:numRef>
            </c:plus>
            <c:minus>
              <c:numRef>
                <c:f>'[Real Time IPO7.xlsx]Riepilogo'!$E$3</c:f>
                <c:numCache>
                  <c:formatCode>General</c:formatCode>
                  <c:ptCount val="1"/>
                  <c:pt idx="0">
                    <c:v>6.807837910009481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Real Time IPO7.xlsx]Riepilogo'!$D$3</c:f>
              <c:numCache>
                <c:formatCode>General</c:formatCode>
                <c:ptCount val="1"/>
                <c:pt idx="0">
                  <c:v>0.596277367027731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38187296"/>
        <c:axId val="738195528"/>
      </c:barChart>
      <c:catAx>
        <c:axId val="7381872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738195528"/>
        <c:crosses val="autoZero"/>
        <c:auto val="1"/>
        <c:lblAlgn val="ctr"/>
        <c:lblOffset val="100"/>
        <c:noMultiLvlLbl val="0"/>
      </c:catAx>
      <c:valAx>
        <c:axId val="7381955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7381872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it-IT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HIF1a lama k562 22-9.xls]Foglio1'!$A$10</c:f>
              <c:strCache>
                <c:ptCount val="1"/>
                <c:pt idx="0">
                  <c:v>Ctrl</c:v>
                </c:pt>
              </c:strCache>
            </c:strRef>
          </c:tx>
          <c:spPr>
            <a:solidFill>
              <a:srgbClr val="5F5F5F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val>
            <c:numRef>
              <c:f>'[HIF1a lama k562 22-9.xls]Foglio1'!$D$10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</c:ser>
        <c:ser>
          <c:idx val="1"/>
          <c:order val="1"/>
          <c:tx>
            <c:strRef>
              <c:f>'[HIF1a lama k562 22-9.xls]Foglio1'!$A$11</c:f>
              <c:strCache>
                <c:ptCount val="1"/>
                <c:pt idx="0">
                  <c:v>Curcu 20 µM</c:v>
                </c:pt>
              </c:strCache>
            </c:strRef>
          </c:tx>
          <c:spPr>
            <a:solidFill>
              <a:srgbClr val="B3B3B3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HIF1a lama k562 22-9.xls]Foglio1'!$E$11</c:f>
                <c:numCache>
                  <c:formatCode>General</c:formatCode>
                  <c:ptCount val="1"/>
                  <c:pt idx="0">
                    <c:v>3.2289268525241159E-2</c:v>
                  </c:pt>
                </c:numCache>
              </c:numRef>
            </c:plus>
            <c:minus>
              <c:numRef>
                <c:f>'[HIF1a lama k562 22-9.xls]Foglio1'!$E$11</c:f>
                <c:numCache>
                  <c:formatCode>General</c:formatCode>
                  <c:ptCount val="1"/>
                  <c:pt idx="0">
                    <c:v>3.228926852524115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HIF1a lama k562 22-9.xls]Foglio1'!$D$11</c:f>
              <c:numCache>
                <c:formatCode>General</c:formatCode>
                <c:ptCount val="1"/>
                <c:pt idx="0">
                  <c:v>1.250813920553272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38196312"/>
        <c:axId val="738197488"/>
      </c:barChart>
      <c:catAx>
        <c:axId val="7381963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738197488"/>
        <c:crosses val="autoZero"/>
        <c:auto val="1"/>
        <c:lblAlgn val="ctr"/>
        <c:lblOffset val="100"/>
        <c:noMultiLvlLbl val="0"/>
      </c:catAx>
      <c:valAx>
        <c:axId val="7381974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73819631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it-IT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F5F5F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val>
            <c:numRef>
              <c:f>'LAMA IPO7 Ctrl-curcu'!$E$2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</c:ser>
        <c:ser>
          <c:idx val="1"/>
          <c:order val="1"/>
          <c:spPr>
            <a:solidFill>
              <a:schemeClr val="bg1">
                <a:lumMod val="6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val>
            <c:numRef>
              <c:f>'LAMA IPO7 Ctrl-curcu'!$E$3</c:f>
              <c:numCache>
                <c:formatCode>General</c:formatCode>
                <c:ptCount val="1"/>
                <c:pt idx="0">
                  <c:v>0.5358046942267131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38197096"/>
        <c:axId val="738189648"/>
      </c:barChart>
      <c:catAx>
        <c:axId val="7381970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738189648"/>
        <c:crosses val="autoZero"/>
        <c:auto val="1"/>
        <c:lblAlgn val="ctr"/>
        <c:lblOffset val="100"/>
        <c:noMultiLvlLbl val="0"/>
      </c:catAx>
      <c:valAx>
        <c:axId val="7381896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7381970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it-IT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7525808733773414E-2"/>
          <c:y val="5.0925925925925923E-2"/>
          <c:w val="0.53704929548137137"/>
          <c:h val="0.7456966316710411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LAMA84!$A$7</c:f>
              <c:strCache>
                <c:ptCount val="1"/>
                <c:pt idx="0">
                  <c:v>Ctrl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AMA84!$F$7</c:f>
                <c:numCache>
                  <c:formatCode>General</c:formatCode>
                  <c:ptCount val="1"/>
                  <c:pt idx="0">
                    <c:v>0.12398900927652121</c:v>
                  </c:pt>
                </c:numCache>
              </c:numRef>
            </c:plus>
            <c:minus>
              <c:numRef>
                <c:f>LAMA84!$F$7</c:f>
                <c:numCache>
                  <c:formatCode>General</c:formatCode>
                  <c:ptCount val="1"/>
                  <c:pt idx="0">
                    <c:v>0.12398900927652121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LAMA84!$E$7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</c:ser>
        <c:ser>
          <c:idx val="1"/>
          <c:order val="1"/>
          <c:tx>
            <c:strRef>
              <c:f>LAMA84!$A$8</c:f>
              <c:strCache>
                <c:ptCount val="1"/>
                <c:pt idx="0">
                  <c:v>+curcu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AMA84!$F$8</c:f>
                <c:numCache>
                  <c:formatCode>General</c:formatCode>
                  <c:ptCount val="1"/>
                  <c:pt idx="0">
                    <c:v>6.2983665729777372E-2</c:v>
                  </c:pt>
                </c:numCache>
              </c:numRef>
            </c:plus>
            <c:minus>
              <c:numRef>
                <c:f>LAMA84!$F$8</c:f>
                <c:numCache>
                  <c:formatCode>General</c:formatCode>
                  <c:ptCount val="1"/>
                  <c:pt idx="0">
                    <c:v>6.298366572977737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AMA84!$E$8</c:f>
              <c:numCache>
                <c:formatCode>General</c:formatCode>
                <c:ptCount val="1"/>
                <c:pt idx="0">
                  <c:v>0.5846889952153109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0"/>
        <c:overlap val="-30"/>
        <c:axId val="738198664"/>
        <c:axId val="738195136"/>
      </c:barChart>
      <c:catAx>
        <c:axId val="7381986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738195136"/>
        <c:crosses val="autoZero"/>
        <c:auto val="1"/>
        <c:lblAlgn val="ctr"/>
        <c:lblOffset val="100"/>
        <c:noMultiLvlLbl val="0"/>
      </c:catAx>
      <c:valAx>
        <c:axId val="7381951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7381986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8013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75865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078934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25586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252167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903323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5005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815079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7294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7735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416785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0B3DBD-190F-4451-8279-B9FD929B36B0}" type="datetimeFigureOut">
              <a:rPr lang="it-IT" smtClean="0"/>
              <a:t>22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59412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G"/><Relationship Id="rId3" Type="http://schemas.openxmlformats.org/officeDocument/2006/relationships/chart" Target="../charts/chart2.xml"/><Relationship Id="rId7" Type="http://schemas.openxmlformats.org/officeDocument/2006/relationships/image" Target="../media/image3.JP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tiff"/><Relationship Id="rId5" Type="http://schemas.openxmlformats.org/officeDocument/2006/relationships/image" Target="../media/image1.tiff"/><Relationship Id="rId10" Type="http://schemas.openxmlformats.org/officeDocument/2006/relationships/chart" Target="../charts/chart5.xml"/><Relationship Id="rId4" Type="http://schemas.openxmlformats.org/officeDocument/2006/relationships/chart" Target="../charts/chart3.xml"/><Relationship Id="rId9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o 5"/>
          <p:cNvGrpSpPr/>
          <p:nvPr/>
        </p:nvGrpSpPr>
        <p:grpSpPr>
          <a:xfrm>
            <a:off x="139700" y="83387"/>
            <a:ext cx="12088216" cy="6535140"/>
            <a:chOff x="139700" y="83387"/>
            <a:chExt cx="12088216" cy="6535140"/>
          </a:xfrm>
        </p:grpSpPr>
        <p:sp>
          <p:nvSpPr>
            <p:cNvPr id="30" name="Rettangolo 29"/>
            <p:cNvSpPr/>
            <p:nvPr/>
          </p:nvSpPr>
          <p:spPr>
            <a:xfrm>
              <a:off x="139700" y="4864201"/>
              <a:ext cx="11939820" cy="175432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Figure </a:t>
              </a:r>
              <a:r>
                <a:rPr lang="en-US" sz="1200" b="1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4. </a:t>
              </a:r>
              <a:r>
                <a:rPr lang="en-GB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ffects </a:t>
              </a:r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Curcumin on HIF-1α </a:t>
              </a:r>
              <a:r>
                <a:rPr lang="en-GB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ity, IPO7 expression and miR22 expression in LAMA84 cells. </a:t>
              </a:r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ssay of the transcriptional activity of HIF-1α showing that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 LAMA84 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 curcumin induced a reduction of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F-1α 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ity compared to control cells. The reported values are the mean of three independent experiments. </a:t>
              </a:r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qPCR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left 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nel) and representative Western blot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right 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nel) show that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 LAMA84 cells curcumin 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eatment did not affect HIF-1α at both mRNA and protein level. The values (FOI: Fold of Induction) in the histogram are normalized against GAPDH and are the mean ± SD of three independent experiments. </a:t>
              </a:r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qPCR demonstrates that in LAMA84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 curcumin induced a decrease of  mRNA IPO7 expression. The values (FOI: Fold of Induction) in the histogram are normalized to GAPDH and are the mean ± SD of three independent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periments. 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Representative western blot and corresponding </a:t>
              </a:r>
              <a:r>
                <a:rPr lang="en-US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nsitogram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wing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hat in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MA84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ells curcumin inhibited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protein expression of IPO7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GB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qRT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PCR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wing the ability of curcumin to induce in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MA84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 a significant increase of miR-22 expression.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lues (FOI: Fold of Induction) in the histogram are normalized against RNU6-2 and are the mean ± SD of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wo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dependent experiments.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 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Western blot assay, actin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as 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sed as loading control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Intensities of proteins bands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ere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lculated from the peak area of 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ensitogram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by using Image J software. 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l: control cells.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atistical significance was calculated vs Ctrl: *p&lt;0.05, **p&lt;0.01.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33" name="Gruppo 232"/>
            <p:cNvGrpSpPr/>
            <p:nvPr/>
          </p:nvGrpSpPr>
          <p:grpSpPr>
            <a:xfrm>
              <a:off x="7621842" y="2473842"/>
              <a:ext cx="2063156" cy="2561551"/>
              <a:chOff x="10054207" y="2945333"/>
              <a:chExt cx="2063156" cy="2647927"/>
            </a:xfrm>
          </p:grpSpPr>
          <p:grpSp>
            <p:nvGrpSpPr>
              <p:cNvPr id="159" name="Gruppo 158"/>
              <p:cNvGrpSpPr/>
              <p:nvPr/>
            </p:nvGrpSpPr>
            <p:grpSpPr>
              <a:xfrm>
                <a:off x="10888232" y="2945333"/>
                <a:ext cx="1229131" cy="461375"/>
                <a:chOff x="6090903" y="306523"/>
                <a:chExt cx="1229131" cy="461375"/>
              </a:xfrm>
            </p:grpSpPr>
            <p:grpSp>
              <p:nvGrpSpPr>
                <p:cNvPr id="43" name="Gruppo 42"/>
                <p:cNvGrpSpPr/>
                <p:nvPr/>
              </p:nvGrpSpPr>
              <p:grpSpPr>
                <a:xfrm>
                  <a:off x="6090903" y="306523"/>
                  <a:ext cx="442185" cy="253916"/>
                  <a:chOff x="2150519" y="3725242"/>
                  <a:chExt cx="442185" cy="253916"/>
                </a:xfrm>
              </p:grpSpPr>
              <p:sp>
                <p:nvSpPr>
                  <p:cNvPr id="33" name="Rettangolo 32"/>
                  <p:cNvSpPr/>
                  <p:nvPr/>
                </p:nvSpPr>
                <p:spPr>
                  <a:xfrm>
                    <a:off x="2150519" y="3813973"/>
                    <a:ext cx="72000" cy="72000"/>
                  </a:xfrm>
                  <a:prstGeom prst="rect">
                    <a:avLst/>
                  </a:prstGeom>
                  <a:solidFill>
                    <a:srgbClr val="5F5F5F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35" name="CasellaDiTesto 34"/>
                  <p:cNvSpPr txBox="1"/>
                  <p:nvPr/>
                </p:nvSpPr>
                <p:spPr>
                  <a:xfrm>
                    <a:off x="2198044" y="3725242"/>
                    <a:ext cx="39466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50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trl</a:t>
                    </a:r>
                    <a:endParaRPr lang="it-IT" sz="105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42" name="Gruppo 41"/>
                <p:cNvGrpSpPr/>
                <p:nvPr/>
              </p:nvGrpSpPr>
              <p:grpSpPr>
                <a:xfrm>
                  <a:off x="6090903" y="513982"/>
                  <a:ext cx="1229131" cy="253916"/>
                  <a:chOff x="3267065" y="3593626"/>
                  <a:chExt cx="1229131" cy="253916"/>
                </a:xfrm>
              </p:grpSpPr>
              <p:sp>
                <p:nvSpPr>
                  <p:cNvPr id="34" name="Rettangolo 33"/>
                  <p:cNvSpPr/>
                  <p:nvPr/>
                </p:nvSpPr>
                <p:spPr>
                  <a:xfrm>
                    <a:off x="3267065" y="3683999"/>
                    <a:ext cx="72000" cy="72000"/>
                  </a:xfrm>
                  <a:prstGeom prst="rect">
                    <a:avLst/>
                  </a:prstGeom>
                  <a:solidFill>
                    <a:srgbClr val="D0CECE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36" name="CasellaDiTesto 35"/>
                  <p:cNvSpPr txBox="1"/>
                  <p:nvPr/>
                </p:nvSpPr>
                <p:spPr>
                  <a:xfrm>
                    <a:off x="3319271" y="3593626"/>
                    <a:ext cx="1176925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50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urcumin</a:t>
                    </a:r>
                    <a:r>
                      <a:rPr lang="it-IT" sz="105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20 µM</a:t>
                    </a:r>
                    <a:endParaRPr lang="it-IT" sz="105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156" name="Gruppo 155"/>
              <p:cNvGrpSpPr/>
              <p:nvPr/>
            </p:nvGrpSpPr>
            <p:grpSpPr>
              <a:xfrm>
                <a:off x="10054207" y="2973797"/>
                <a:ext cx="1593163" cy="2619463"/>
                <a:chOff x="9701007" y="2933704"/>
                <a:chExt cx="1593163" cy="2619463"/>
              </a:xfrm>
            </p:grpSpPr>
            <p:grpSp>
              <p:nvGrpSpPr>
                <p:cNvPr id="41" name="Gruppo 40"/>
                <p:cNvGrpSpPr/>
                <p:nvPr/>
              </p:nvGrpSpPr>
              <p:grpSpPr>
                <a:xfrm>
                  <a:off x="9729785" y="3231689"/>
                  <a:ext cx="1564385" cy="2321478"/>
                  <a:chOff x="3199465" y="682144"/>
                  <a:chExt cx="1774372" cy="2743200"/>
                </a:xfrm>
              </p:grpSpPr>
              <p:graphicFrame>
                <p:nvGraphicFramePr>
                  <p:cNvPr id="10" name="Grafico 9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916008427"/>
                      </p:ext>
                    </p:extLst>
                  </p:nvPr>
                </p:nvGraphicFramePr>
                <p:xfrm>
                  <a:off x="3199465" y="682144"/>
                  <a:ext cx="1774372" cy="27432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2"/>
                  </a:graphicData>
                </a:graphic>
              </p:graphicFrame>
              <p:sp>
                <p:nvSpPr>
                  <p:cNvPr id="13" name="Rettangolo 12"/>
                  <p:cNvSpPr/>
                  <p:nvPr/>
                </p:nvSpPr>
                <p:spPr>
                  <a:xfrm>
                    <a:off x="4118628" y="3149524"/>
                    <a:ext cx="489857" cy="1524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</p:grpSp>
            <p:sp>
              <p:nvSpPr>
                <p:cNvPr id="53" name="CasellaDiTesto 52"/>
                <p:cNvSpPr txBox="1"/>
                <p:nvPr/>
              </p:nvSpPr>
              <p:spPr>
                <a:xfrm>
                  <a:off x="9701007" y="2933704"/>
                  <a:ext cx="304432" cy="3817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  <a:endParaRPr lang="it-IT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238" name="Gruppo 237"/>
            <p:cNvGrpSpPr/>
            <p:nvPr/>
          </p:nvGrpSpPr>
          <p:grpSpPr>
            <a:xfrm>
              <a:off x="9449767" y="83387"/>
              <a:ext cx="2778149" cy="2429326"/>
              <a:chOff x="9449767" y="83387"/>
              <a:chExt cx="2778149" cy="2429326"/>
            </a:xfrm>
          </p:grpSpPr>
          <p:grpSp>
            <p:nvGrpSpPr>
              <p:cNvPr id="17" name="Gruppo 16"/>
              <p:cNvGrpSpPr/>
              <p:nvPr/>
            </p:nvGrpSpPr>
            <p:grpSpPr>
              <a:xfrm>
                <a:off x="9449767" y="83387"/>
                <a:ext cx="1952855" cy="2429326"/>
                <a:chOff x="-121796" y="3643576"/>
                <a:chExt cx="1952855" cy="2429326"/>
              </a:xfrm>
            </p:grpSpPr>
            <p:sp>
              <p:nvSpPr>
                <p:cNvPr id="60" name="CasellaDiTesto 59"/>
                <p:cNvSpPr txBox="1"/>
                <p:nvPr/>
              </p:nvSpPr>
              <p:spPr>
                <a:xfrm>
                  <a:off x="1177074" y="4429936"/>
                  <a:ext cx="35242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it-IT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5" name="Gruppo 14"/>
                <p:cNvGrpSpPr/>
                <p:nvPr/>
              </p:nvGrpSpPr>
              <p:grpSpPr>
                <a:xfrm>
                  <a:off x="-121796" y="3643576"/>
                  <a:ext cx="1952855" cy="2429326"/>
                  <a:chOff x="701640" y="3815304"/>
                  <a:chExt cx="1952855" cy="2429326"/>
                </a:xfrm>
              </p:grpSpPr>
              <p:grpSp>
                <p:nvGrpSpPr>
                  <p:cNvPr id="8" name="Gruppo 7"/>
                  <p:cNvGrpSpPr/>
                  <p:nvPr/>
                </p:nvGrpSpPr>
                <p:grpSpPr>
                  <a:xfrm>
                    <a:off x="701640" y="3815304"/>
                    <a:ext cx="1952855" cy="2429326"/>
                    <a:chOff x="701640" y="3815304"/>
                    <a:chExt cx="1952855" cy="2429326"/>
                  </a:xfrm>
                </p:grpSpPr>
                <p:sp>
                  <p:nvSpPr>
                    <p:cNvPr id="26" name="CasellaDiTesto 25"/>
                    <p:cNvSpPr txBox="1"/>
                    <p:nvPr/>
                  </p:nvSpPr>
                  <p:spPr>
                    <a:xfrm>
                      <a:off x="701640" y="3833876"/>
                      <a:ext cx="304432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it-IT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p:txBody>
                </p:sp>
                <p:graphicFrame>
                  <p:nvGraphicFramePr>
                    <p:cNvPr id="59" name="Grafico 58"/>
                    <p:cNvGraphicFramePr>
                      <a:graphicFrameLocks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2477291515"/>
                        </p:ext>
                      </p:extLst>
                    </p:nvPr>
                  </p:nvGraphicFramePr>
                  <p:xfrm>
                    <a:off x="1245434" y="3843619"/>
                    <a:ext cx="1409061" cy="2401011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3"/>
                    </a:graphicData>
                  </a:graphic>
                </p:graphicFrame>
                <p:sp>
                  <p:nvSpPr>
                    <p:cNvPr id="4" name="CasellaDiTesto 3"/>
                    <p:cNvSpPr txBox="1"/>
                    <p:nvPr/>
                  </p:nvSpPr>
                  <p:spPr>
                    <a:xfrm rot="16200000">
                      <a:off x="-72929" y="4767338"/>
                      <a:ext cx="2304177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it-IT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I of  IPO7</a:t>
                      </a:r>
                      <a:r>
                        <a:rPr lang="el-G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0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NA</a:t>
                      </a:r>
                      <a:endParaRPr lang="it-IT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it-IT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0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ression</a:t>
                      </a:r>
                      <a:endPara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77" name="Rettangolo 76"/>
                  <p:cNvSpPr/>
                  <p:nvPr/>
                </p:nvSpPr>
                <p:spPr>
                  <a:xfrm>
                    <a:off x="1728287" y="6026902"/>
                    <a:ext cx="489857" cy="1524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</p:grpSp>
          </p:grpSp>
          <p:grpSp>
            <p:nvGrpSpPr>
              <p:cNvPr id="201" name="Gruppo 200"/>
              <p:cNvGrpSpPr/>
              <p:nvPr/>
            </p:nvGrpSpPr>
            <p:grpSpPr>
              <a:xfrm>
                <a:off x="10998785" y="331851"/>
                <a:ext cx="1229131" cy="461375"/>
                <a:chOff x="6090903" y="306523"/>
                <a:chExt cx="1229131" cy="461375"/>
              </a:xfrm>
            </p:grpSpPr>
            <p:grpSp>
              <p:nvGrpSpPr>
                <p:cNvPr id="202" name="Gruppo 201"/>
                <p:cNvGrpSpPr/>
                <p:nvPr/>
              </p:nvGrpSpPr>
              <p:grpSpPr>
                <a:xfrm>
                  <a:off x="6090903" y="306523"/>
                  <a:ext cx="442185" cy="253916"/>
                  <a:chOff x="2150519" y="3725242"/>
                  <a:chExt cx="442185" cy="253916"/>
                </a:xfrm>
              </p:grpSpPr>
              <p:sp>
                <p:nvSpPr>
                  <p:cNvPr id="206" name="Rettangolo 205"/>
                  <p:cNvSpPr/>
                  <p:nvPr/>
                </p:nvSpPr>
                <p:spPr>
                  <a:xfrm>
                    <a:off x="2150519" y="3813973"/>
                    <a:ext cx="72000" cy="72000"/>
                  </a:xfrm>
                  <a:prstGeom prst="rect">
                    <a:avLst/>
                  </a:prstGeom>
                  <a:solidFill>
                    <a:srgbClr val="5F5F5F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207" name="CasellaDiTesto 206"/>
                  <p:cNvSpPr txBox="1"/>
                  <p:nvPr/>
                </p:nvSpPr>
                <p:spPr>
                  <a:xfrm>
                    <a:off x="2198044" y="3725242"/>
                    <a:ext cx="39466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50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trl</a:t>
                    </a:r>
                    <a:endParaRPr lang="it-IT" sz="105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203" name="Gruppo 202"/>
                <p:cNvGrpSpPr/>
                <p:nvPr/>
              </p:nvGrpSpPr>
              <p:grpSpPr>
                <a:xfrm>
                  <a:off x="6090903" y="513982"/>
                  <a:ext cx="1229131" cy="253916"/>
                  <a:chOff x="3267065" y="3593626"/>
                  <a:chExt cx="1229131" cy="253916"/>
                </a:xfrm>
              </p:grpSpPr>
              <p:sp>
                <p:nvSpPr>
                  <p:cNvPr id="204" name="Rettangolo 203"/>
                  <p:cNvSpPr/>
                  <p:nvPr/>
                </p:nvSpPr>
                <p:spPr>
                  <a:xfrm>
                    <a:off x="3267065" y="3683999"/>
                    <a:ext cx="72000" cy="72000"/>
                  </a:xfrm>
                  <a:prstGeom prst="rect">
                    <a:avLst/>
                  </a:prstGeom>
                  <a:solidFill>
                    <a:srgbClr val="D0CECE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205" name="CasellaDiTesto 204"/>
                  <p:cNvSpPr txBox="1"/>
                  <p:nvPr/>
                </p:nvSpPr>
                <p:spPr>
                  <a:xfrm>
                    <a:off x="3319271" y="3593626"/>
                    <a:ext cx="1176925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50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urcumin</a:t>
                    </a:r>
                    <a:r>
                      <a:rPr lang="it-IT" sz="105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20 µM</a:t>
                    </a:r>
                    <a:endParaRPr lang="it-IT" sz="105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grpSp>
          <p:nvGrpSpPr>
            <p:cNvPr id="231" name="Gruppo 230"/>
            <p:cNvGrpSpPr/>
            <p:nvPr/>
          </p:nvGrpSpPr>
          <p:grpSpPr>
            <a:xfrm>
              <a:off x="4279738" y="99801"/>
              <a:ext cx="4984646" cy="2363519"/>
              <a:chOff x="3860638" y="99801"/>
              <a:chExt cx="4984646" cy="2363519"/>
            </a:xfrm>
          </p:grpSpPr>
          <p:grpSp>
            <p:nvGrpSpPr>
              <p:cNvPr id="160" name="Gruppo 159"/>
              <p:cNvGrpSpPr/>
              <p:nvPr/>
            </p:nvGrpSpPr>
            <p:grpSpPr>
              <a:xfrm>
                <a:off x="3860638" y="121424"/>
                <a:ext cx="4984646" cy="2341896"/>
                <a:chOff x="3425758" y="80436"/>
                <a:chExt cx="4984646" cy="2341896"/>
              </a:xfrm>
            </p:grpSpPr>
            <p:grpSp>
              <p:nvGrpSpPr>
                <p:cNvPr id="40" name="Gruppo 39"/>
                <p:cNvGrpSpPr/>
                <p:nvPr/>
              </p:nvGrpSpPr>
              <p:grpSpPr>
                <a:xfrm>
                  <a:off x="4081518" y="202443"/>
                  <a:ext cx="1469789" cy="2219889"/>
                  <a:chOff x="967563" y="981058"/>
                  <a:chExt cx="1769804" cy="2699399"/>
                </a:xfrm>
              </p:grpSpPr>
              <p:graphicFrame>
                <p:nvGraphicFramePr>
                  <p:cNvPr id="11" name="Grafico 10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3446164077"/>
                      </p:ext>
                    </p:extLst>
                  </p:nvPr>
                </p:nvGraphicFramePr>
                <p:xfrm>
                  <a:off x="967563" y="981058"/>
                  <a:ext cx="1769804" cy="2699399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4"/>
                  </a:graphicData>
                </a:graphic>
              </p:graphicFrame>
              <p:sp>
                <p:nvSpPr>
                  <p:cNvPr id="12" name="Rettangolo 11"/>
                  <p:cNvSpPr/>
                  <p:nvPr/>
                </p:nvSpPr>
                <p:spPr>
                  <a:xfrm>
                    <a:off x="1705106" y="3412110"/>
                    <a:ext cx="489857" cy="1524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</p:grpSp>
            <p:sp>
              <p:nvSpPr>
                <p:cNvPr id="29" name="CasellaDiTesto 28"/>
                <p:cNvSpPr txBox="1"/>
                <p:nvPr/>
              </p:nvSpPr>
              <p:spPr>
                <a:xfrm>
                  <a:off x="3425758" y="80436"/>
                  <a:ext cx="30443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  <a:endParaRPr lang="it-IT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25" name="Gruppo 24"/>
                <p:cNvGrpSpPr/>
                <p:nvPr/>
              </p:nvGrpSpPr>
              <p:grpSpPr>
                <a:xfrm>
                  <a:off x="5516340" y="659026"/>
                  <a:ext cx="2894064" cy="1162013"/>
                  <a:chOff x="5921065" y="1337867"/>
                  <a:chExt cx="2894064" cy="1162013"/>
                </a:xfrm>
              </p:grpSpPr>
              <p:pic>
                <p:nvPicPr>
                  <p:cNvPr id="97" name="Immagine 96"/>
                  <p:cNvPicPr>
                    <a:picLocks noChangeAspect="1"/>
                  </p:cNvPicPr>
                  <p:nvPr/>
                </p:nvPicPr>
                <p:blipFill rotWithShape="1"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5622" t="40198" r="66552" b="46591"/>
                  <a:stretch/>
                </p:blipFill>
                <p:spPr>
                  <a:xfrm>
                    <a:off x="7129444" y="1337867"/>
                    <a:ext cx="850089" cy="470586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98" name="Immagine 97"/>
                  <p:cNvPicPr>
                    <a:picLocks noChangeAspect="1"/>
                  </p:cNvPicPr>
                  <p:nvPr/>
                </p:nvPicPr>
                <p:blipFill rotWithShape="1"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3580" t="53409" r="57958" b="35510"/>
                  <a:stretch/>
                </p:blipFill>
                <p:spPr>
                  <a:xfrm>
                    <a:off x="7129444" y="1841111"/>
                    <a:ext cx="850089" cy="381074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99" name="CasellaDiTesto 98"/>
                  <p:cNvSpPr txBox="1"/>
                  <p:nvPr/>
                </p:nvSpPr>
                <p:spPr>
                  <a:xfrm>
                    <a:off x="7208601" y="2214560"/>
                    <a:ext cx="23596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  <a:endParaRPr lang="it-IT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0" name="CasellaDiTesto 99"/>
                  <p:cNvSpPr txBox="1"/>
                  <p:nvPr/>
                </p:nvSpPr>
                <p:spPr>
                  <a:xfrm>
                    <a:off x="7630743" y="2219260"/>
                    <a:ext cx="27443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it-IT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1" name="CasellaDiTesto 100"/>
                  <p:cNvSpPr txBox="1"/>
                  <p:nvPr/>
                </p:nvSpPr>
                <p:spPr>
                  <a:xfrm>
                    <a:off x="5921065" y="2245964"/>
                    <a:ext cx="1226618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50" b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urcumin</a:t>
                    </a:r>
                    <a:r>
                      <a:rPr lang="it-IT" sz="105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20 µM</a:t>
                    </a:r>
                    <a:endParaRPr lang="it-IT" sz="105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2" name="CasellaDiTesto 101"/>
                  <p:cNvSpPr txBox="1"/>
                  <p:nvPr/>
                </p:nvSpPr>
                <p:spPr>
                  <a:xfrm>
                    <a:off x="7986618" y="1488003"/>
                    <a:ext cx="604653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5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IF-1</a:t>
                    </a:r>
                    <a:r>
                      <a:rPr lang="el-GR" sz="105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</a:t>
                    </a:r>
                    <a:endParaRPr lang="it-IT" sz="105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3" name="CasellaDiTesto 102"/>
                  <p:cNvSpPr txBox="1"/>
                  <p:nvPr/>
                </p:nvSpPr>
                <p:spPr>
                  <a:xfrm>
                    <a:off x="7957203" y="1851433"/>
                    <a:ext cx="857926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5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eta </a:t>
                    </a:r>
                    <a:r>
                      <a:rPr lang="it-IT" sz="1050" b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ctin</a:t>
                    </a:r>
                    <a:endParaRPr lang="it-IT" sz="105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58" name="Rettangolo 157"/>
                <p:cNvSpPr/>
                <p:nvPr/>
              </p:nvSpPr>
              <p:spPr>
                <a:xfrm rot="16200000">
                  <a:off x="3121427" y="1224825"/>
                  <a:ext cx="1313965" cy="400110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>
                    <a:defRPr sz="1000" b="0" i="0" u="none" strike="noStrike" kern="1200" baseline="0">
                      <a:solidFill>
                        <a:prstClr val="black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r>
                    <a:rPr lang="it-IT" dirty="0"/>
                    <a:t>FOI HIF-1</a:t>
                  </a:r>
                  <a:r>
                    <a:rPr lang="el-GR" dirty="0"/>
                    <a:t>α</a:t>
                  </a:r>
                  <a:r>
                    <a:rPr lang="it-IT" dirty="0"/>
                    <a:t> </a:t>
                  </a:r>
                  <a:r>
                    <a:rPr lang="it-IT" dirty="0" err="1"/>
                    <a:t>mRNA</a:t>
                  </a:r>
                  <a:endParaRPr lang="it-IT" dirty="0"/>
                </a:p>
                <a:p>
                  <a:pPr algn="ctr">
                    <a:defRPr sz="1000" b="0" i="0" u="none" strike="noStrike" kern="1200" baseline="0">
                      <a:solidFill>
                        <a:prstClr val="black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r>
                    <a:rPr lang="it-IT" dirty="0"/>
                    <a:t> </a:t>
                  </a:r>
                  <a:r>
                    <a:rPr lang="it-IT" dirty="0" err="1"/>
                    <a:t>expression</a:t>
                  </a:r>
                  <a:endParaRPr lang="it-IT" dirty="0"/>
                </a:p>
              </p:txBody>
            </p:sp>
          </p:grpSp>
          <p:grpSp>
            <p:nvGrpSpPr>
              <p:cNvPr id="208" name="Gruppo 207"/>
              <p:cNvGrpSpPr/>
              <p:nvPr/>
            </p:nvGrpSpPr>
            <p:grpSpPr>
              <a:xfrm>
                <a:off x="5781587" y="99801"/>
                <a:ext cx="1229131" cy="461375"/>
                <a:chOff x="6090903" y="306523"/>
                <a:chExt cx="1229131" cy="461375"/>
              </a:xfrm>
            </p:grpSpPr>
            <p:grpSp>
              <p:nvGrpSpPr>
                <p:cNvPr id="209" name="Gruppo 208"/>
                <p:cNvGrpSpPr/>
                <p:nvPr/>
              </p:nvGrpSpPr>
              <p:grpSpPr>
                <a:xfrm>
                  <a:off x="6090903" y="306523"/>
                  <a:ext cx="442185" cy="253916"/>
                  <a:chOff x="2150519" y="3725242"/>
                  <a:chExt cx="442185" cy="253916"/>
                </a:xfrm>
              </p:grpSpPr>
              <p:sp>
                <p:nvSpPr>
                  <p:cNvPr id="213" name="Rettangolo 212"/>
                  <p:cNvSpPr/>
                  <p:nvPr/>
                </p:nvSpPr>
                <p:spPr>
                  <a:xfrm>
                    <a:off x="2150519" y="3813973"/>
                    <a:ext cx="72000" cy="72000"/>
                  </a:xfrm>
                  <a:prstGeom prst="rect">
                    <a:avLst/>
                  </a:prstGeom>
                  <a:solidFill>
                    <a:srgbClr val="5F5F5F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214" name="CasellaDiTesto 213"/>
                  <p:cNvSpPr txBox="1"/>
                  <p:nvPr/>
                </p:nvSpPr>
                <p:spPr>
                  <a:xfrm>
                    <a:off x="2198044" y="3725242"/>
                    <a:ext cx="39466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50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trl</a:t>
                    </a:r>
                    <a:endParaRPr lang="it-IT" sz="105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210" name="Gruppo 209"/>
                <p:cNvGrpSpPr/>
                <p:nvPr/>
              </p:nvGrpSpPr>
              <p:grpSpPr>
                <a:xfrm>
                  <a:off x="6090903" y="513982"/>
                  <a:ext cx="1229131" cy="253916"/>
                  <a:chOff x="3267065" y="3593626"/>
                  <a:chExt cx="1229131" cy="253916"/>
                </a:xfrm>
              </p:grpSpPr>
              <p:sp>
                <p:nvSpPr>
                  <p:cNvPr id="211" name="Rettangolo 210"/>
                  <p:cNvSpPr/>
                  <p:nvPr/>
                </p:nvSpPr>
                <p:spPr>
                  <a:xfrm>
                    <a:off x="3267065" y="3683999"/>
                    <a:ext cx="72000" cy="72000"/>
                  </a:xfrm>
                  <a:prstGeom prst="rect">
                    <a:avLst/>
                  </a:prstGeom>
                  <a:solidFill>
                    <a:srgbClr val="D0CECE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212" name="CasellaDiTesto 211"/>
                  <p:cNvSpPr txBox="1"/>
                  <p:nvPr/>
                </p:nvSpPr>
                <p:spPr>
                  <a:xfrm>
                    <a:off x="3319271" y="3593626"/>
                    <a:ext cx="1176925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50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urcumin</a:t>
                    </a:r>
                    <a:r>
                      <a:rPr lang="it-IT" sz="105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20 µM</a:t>
                    </a:r>
                    <a:endParaRPr lang="it-IT" sz="105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grpSp>
          <p:nvGrpSpPr>
            <p:cNvPr id="235" name="Gruppo 234"/>
            <p:cNvGrpSpPr/>
            <p:nvPr/>
          </p:nvGrpSpPr>
          <p:grpSpPr>
            <a:xfrm>
              <a:off x="1885942" y="2572353"/>
              <a:ext cx="5121975" cy="2436453"/>
              <a:chOff x="-18624" y="2602737"/>
              <a:chExt cx="5121975" cy="2436453"/>
            </a:xfrm>
          </p:grpSpPr>
          <p:grpSp>
            <p:nvGrpSpPr>
              <p:cNvPr id="234" name="Gruppo 233"/>
              <p:cNvGrpSpPr/>
              <p:nvPr/>
            </p:nvGrpSpPr>
            <p:grpSpPr>
              <a:xfrm>
                <a:off x="-18624" y="2734891"/>
                <a:ext cx="4579439" cy="2304299"/>
                <a:chOff x="82976" y="2836491"/>
                <a:chExt cx="4579439" cy="2304299"/>
              </a:xfrm>
            </p:grpSpPr>
            <p:sp>
              <p:nvSpPr>
                <p:cNvPr id="69" name="CasellaDiTesto 68"/>
                <p:cNvSpPr txBox="1"/>
                <p:nvPr/>
              </p:nvSpPr>
              <p:spPr>
                <a:xfrm>
                  <a:off x="1026197" y="2869169"/>
                  <a:ext cx="32496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  <a:endParaRPr lang="it-IT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9" name="Gruppo 18"/>
                <p:cNvGrpSpPr/>
                <p:nvPr/>
              </p:nvGrpSpPr>
              <p:grpSpPr>
                <a:xfrm>
                  <a:off x="82976" y="3340104"/>
                  <a:ext cx="2904588" cy="1088065"/>
                  <a:chOff x="3236546" y="4326550"/>
                  <a:chExt cx="2904588" cy="1088065"/>
                </a:xfrm>
              </p:grpSpPr>
              <p:pic>
                <p:nvPicPr>
                  <p:cNvPr id="5" name="Immagine 4"/>
                  <p:cNvPicPr>
                    <a:picLocks noChangeAspect="1"/>
                  </p:cNvPicPr>
                  <p:nvPr/>
                </p:nvPicPr>
                <p:blipFill rotWithShape="1"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8750" b="60142"/>
                  <a:stretch/>
                </p:blipFill>
                <p:spPr>
                  <a:xfrm>
                    <a:off x="4426798" y="4771891"/>
                    <a:ext cx="885825" cy="404949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68" name="Immagine 67"/>
                  <p:cNvPicPr>
                    <a:picLocks noChangeAspect="1"/>
                  </p:cNvPicPr>
                  <p:nvPr/>
                </p:nvPicPr>
                <p:blipFill rotWithShape="1">
                  <a:blip r:embed="rId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20447" b="51791"/>
                  <a:stretch/>
                </p:blipFill>
                <p:spPr>
                  <a:xfrm>
                    <a:off x="4426798" y="4326550"/>
                    <a:ext cx="885825" cy="354330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79" name="CasellaDiTesto 78"/>
                  <p:cNvSpPr txBox="1"/>
                  <p:nvPr/>
                </p:nvSpPr>
                <p:spPr>
                  <a:xfrm>
                    <a:off x="4512834" y="5132916"/>
                    <a:ext cx="23596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  <a:endParaRPr lang="it-IT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0" name="CasellaDiTesto 79"/>
                  <p:cNvSpPr txBox="1"/>
                  <p:nvPr/>
                </p:nvSpPr>
                <p:spPr>
                  <a:xfrm>
                    <a:off x="4956748" y="5137616"/>
                    <a:ext cx="27443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it-IT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1" name="CasellaDiTesto 80"/>
                  <p:cNvSpPr txBox="1"/>
                  <p:nvPr/>
                </p:nvSpPr>
                <p:spPr>
                  <a:xfrm>
                    <a:off x="3236546" y="5151819"/>
                    <a:ext cx="1226618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50" b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urcumin</a:t>
                    </a:r>
                    <a:r>
                      <a:rPr lang="it-IT" sz="105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20 µM</a:t>
                    </a:r>
                    <a:endParaRPr lang="it-IT" sz="105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2" name="CasellaDiTesto 81"/>
                  <p:cNvSpPr txBox="1"/>
                  <p:nvPr/>
                </p:nvSpPr>
                <p:spPr>
                  <a:xfrm>
                    <a:off x="5312623" y="4460789"/>
                    <a:ext cx="505267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5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PO7</a:t>
                    </a:r>
                    <a:endParaRPr lang="it-IT" sz="105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3" name="CasellaDiTesto 82"/>
                  <p:cNvSpPr txBox="1"/>
                  <p:nvPr/>
                </p:nvSpPr>
                <p:spPr>
                  <a:xfrm>
                    <a:off x="5283208" y="4824219"/>
                    <a:ext cx="857926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5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eta </a:t>
                    </a:r>
                    <a:r>
                      <a:rPr lang="it-IT" sz="1050" b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ctin</a:t>
                    </a:r>
                    <a:endParaRPr lang="it-IT" sz="105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62" name="Gruppo 161"/>
                <p:cNvGrpSpPr/>
                <p:nvPr/>
              </p:nvGrpSpPr>
              <p:grpSpPr>
                <a:xfrm>
                  <a:off x="3018853" y="2836491"/>
                  <a:ext cx="1643562" cy="2304299"/>
                  <a:chOff x="626700" y="4256468"/>
                  <a:chExt cx="1643562" cy="2304299"/>
                </a:xfrm>
              </p:grpSpPr>
              <p:grpSp>
                <p:nvGrpSpPr>
                  <p:cNvPr id="18" name="Gruppo 17"/>
                  <p:cNvGrpSpPr/>
                  <p:nvPr/>
                </p:nvGrpSpPr>
                <p:grpSpPr>
                  <a:xfrm>
                    <a:off x="626700" y="4256468"/>
                    <a:ext cx="1643562" cy="2304299"/>
                    <a:chOff x="6245298" y="3812198"/>
                    <a:chExt cx="2046674" cy="2631961"/>
                  </a:xfrm>
                </p:grpSpPr>
                <p:graphicFrame>
                  <p:nvGraphicFramePr>
                    <p:cNvPr id="70" name="Grafico 69"/>
                    <p:cNvGraphicFramePr>
                      <a:graphicFrameLocks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2820658250"/>
                        </p:ext>
                      </p:extLst>
                    </p:nvPr>
                  </p:nvGraphicFramePr>
                  <p:xfrm>
                    <a:off x="6663772" y="3812198"/>
                    <a:ext cx="1628200" cy="2631961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9"/>
                    </a:graphicData>
                  </a:graphic>
                </p:graphicFrame>
                <p:sp>
                  <p:nvSpPr>
                    <p:cNvPr id="85" name="CasellaDiTesto 84"/>
                    <p:cNvSpPr txBox="1"/>
                    <p:nvPr/>
                  </p:nvSpPr>
                  <p:spPr>
                    <a:xfrm rot="16200000">
                      <a:off x="5879955" y="4722686"/>
                      <a:ext cx="1228930" cy="4982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it-IT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O7/Beta </a:t>
                      </a:r>
                      <a:r>
                        <a:rPr lang="it-IT" sz="10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n</a:t>
                      </a:r>
                      <a:endParaRPr lang="it-IT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it-IT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it-IT" sz="10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</a:t>
                      </a:r>
                      <a:r>
                        <a:rPr lang="it-IT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f </a:t>
                      </a:r>
                      <a:r>
                        <a:rPr lang="it-IT" sz="10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l</a:t>
                      </a:r>
                      <a:r>
                        <a:rPr lang="it-IT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p:txBody>
                </p:sp>
              </p:grpSp>
              <p:sp>
                <p:nvSpPr>
                  <p:cNvPr id="113" name="Rettangolo 112"/>
                  <p:cNvSpPr/>
                  <p:nvPr/>
                </p:nvSpPr>
                <p:spPr>
                  <a:xfrm>
                    <a:off x="1417688" y="6359240"/>
                    <a:ext cx="489857" cy="1524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</p:grpSp>
          </p:grpSp>
          <p:grpSp>
            <p:nvGrpSpPr>
              <p:cNvPr id="215" name="Gruppo 214"/>
              <p:cNvGrpSpPr/>
              <p:nvPr/>
            </p:nvGrpSpPr>
            <p:grpSpPr>
              <a:xfrm>
                <a:off x="3874220" y="2602737"/>
                <a:ext cx="1229131" cy="461375"/>
                <a:chOff x="6090903" y="306523"/>
                <a:chExt cx="1229131" cy="461375"/>
              </a:xfrm>
            </p:grpSpPr>
            <p:grpSp>
              <p:nvGrpSpPr>
                <p:cNvPr id="216" name="Gruppo 215"/>
                <p:cNvGrpSpPr/>
                <p:nvPr/>
              </p:nvGrpSpPr>
              <p:grpSpPr>
                <a:xfrm>
                  <a:off x="6090903" y="306523"/>
                  <a:ext cx="442185" cy="253916"/>
                  <a:chOff x="2150519" y="3725242"/>
                  <a:chExt cx="442185" cy="253916"/>
                </a:xfrm>
              </p:grpSpPr>
              <p:sp>
                <p:nvSpPr>
                  <p:cNvPr id="220" name="Rettangolo 219"/>
                  <p:cNvSpPr/>
                  <p:nvPr/>
                </p:nvSpPr>
                <p:spPr>
                  <a:xfrm>
                    <a:off x="2150519" y="3813973"/>
                    <a:ext cx="72000" cy="72000"/>
                  </a:xfrm>
                  <a:prstGeom prst="rect">
                    <a:avLst/>
                  </a:prstGeom>
                  <a:solidFill>
                    <a:srgbClr val="5F5F5F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221" name="CasellaDiTesto 220"/>
                  <p:cNvSpPr txBox="1"/>
                  <p:nvPr/>
                </p:nvSpPr>
                <p:spPr>
                  <a:xfrm>
                    <a:off x="2198044" y="3725242"/>
                    <a:ext cx="39466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50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trl</a:t>
                    </a:r>
                    <a:endParaRPr lang="it-IT" sz="105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217" name="Gruppo 216"/>
                <p:cNvGrpSpPr/>
                <p:nvPr/>
              </p:nvGrpSpPr>
              <p:grpSpPr>
                <a:xfrm>
                  <a:off x="6090903" y="513982"/>
                  <a:ext cx="1229131" cy="253916"/>
                  <a:chOff x="3267065" y="3593626"/>
                  <a:chExt cx="1229131" cy="253916"/>
                </a:xfrm>
              </p:grpSpPr>
              <p:sp>
                <p:nvSpPr>
                  <p:cNvPr id="218" name="Rettangolo 217"/>
                  <p:cNvSpPr/>
                  <p:nvPr/>
                </p:nvSpPr>
                <p:spPr>
                  <a:xfrm>
                    <a:off x="3267065" y="3683999"/>
                    <a:ext cx="72000" cy="72000"/>
                  </a:xfrm>
                  <a:prstGeom prst="rect">
                    <a:avLst/>
                  </a:prstGeom>
                  <a:solidFill>
                    <a:srgbClr val="D0CECE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219" name="CasellaDiTesto 218"/>
                  <p:cNvSpPr txBox="1"/>
                  <p:nvPr/>
                </p:nvSpPr>
                <p:spPr>
                  <a:xfrm>
                    <a:off x="3319271" y="3593626"/>
                    <a:ext cx="1176925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50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urcumin</a:t>
                    </a:r>
                    <a:r>
                      <a:rPr lang="it-IT" sz="105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20 µM</a:t>
                    </a:r>
                    <a:endParaRPr lang="it-IT" sz="105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grpSp>
          <p:nvGrpSpPr>
            <p:cNvPr id="3" name="Gruppo 2"/>
            <p:cNvGrpSpPr/>
            <p:nvPr/>
          </p:nvGrpSpPr>
          <p:grpSpPr>
            <a:xfrm>
              <a:off x="410664" y="229961"/>
              <a:ext cx="3130871" cy="2765662"/>
              <a:chOff x="323357" y="417337"/>
              <a:chExt cx="3130871" cy="2765662"/>
            </a:xfrm>
          </p:grpSpPr>
          <p:grpSp>
            <p:nvGrpSpPr>
              <p:cNvPr id="166" name="Gruppo 165"/>
              <p:cNvGrpSpPr/>
              <p:nvPr/>
            </p:nvGrpSpPr>
            <p:grpSpPr>
              <a:xfrm>
                <a:off x="323357" y="481421"/>
                <a:ext cx="2797477" cy="2701578"/>
                <a:chOff x="710609" y="142760"/>
                <a:chExt cx="2797477" cy="2701578"/>
              </a:xfrm>
              <a:noFill/>
            </p:grpSpPr>
            <p:sp>
              <p:nvSpPr>
                <p:cNvPr id="39" name="CasellaDiTesto 38"/>
                <p:cNvSpPr txBox="1"/>
                <p:nvPr/>
              </p:nvSpPr>
              <p:spPr>
                <a:xfrm>
                  <a:off x="710609" y="174955"/>
                  <a:ext cx="304432" cy="369332"/>
                </a:xfrm>
                <a:prstGeom prst="rect">
                  <a:avLst/>
                </a:prstGeom>
                <a:grp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  <p:grpSp>
              <p:nvGrpSpPr>
                <p:cNvPr id="157" name="Gruppo 156"/>
                <p:cNvGrpSpPr/>
                <p:nvPr/>
              </p:nvGrpSpPr>
              <p:grpSpPr>
                <a:xfrm>
                  <a:off x="914351" y="142760"/>
                  <a:ext cx="2593735" cy="2701578"/>
                  <a:chOff x="230216" y="202443"/>
                  <a:chExt cx="2593735" cy="2701578"/>
                </a:xfrm>
                <a:grpFill/>
              </p:grpSpPr>
              <p:graphicFrame>
                <p:nvGraphicFramePr>
                  <p:cNvPr id="31" name="Grafico 30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274888321"/>
                      </p:ext>
                    </p:extLst>
                  </p:nvPr>
                </p:nvGraphicFramePr>
                <p:xfrm>
                  <a:off x="612060" y="202443"/>
                  <a:ext cx="2211891" cy="2701578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10"/>
                  </a:graphicData>
                </a:graphic>
              </p:graphicFrame>
              <p:sp>
                <p:nvSpPr>
                  <p:cNvPr id="32" name="CasellaDiTesto 31"/>
                  <p:cNvSpPr txBox="1"/>
                  <p:nvPr/>
                </p:nvSpPr>
                <p:spPr>
                  <a:xfrm rot="16200000">
                    <a:off x="-352956" y="1172775"/>
                    <a:ext cx="1566454" cy="400110"/>
                  </a:xfrm>
                  <a:prstGeom prst="rect">
                    <a:avLst/>
                  </a:prstGeom>
                  <a:grp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it-IT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IF-1</a:t>
                    </a:r>
                    <a:r>
                      <a:rPr lang="el-GR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</a:t>
                    </a:r>
                    <a:r>
                      <a:rPr lang="it-IT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it-IT" sz="1000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ctivity</a:t>
                    </a:r>
                    <a:endParaRPr lang="it-IT" sz="1000" dirty="0" smtClean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ctr"/>
                    <a:r>
                      <a:rPr lang="it-IT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</a:t>
                    </a:r>
                    <a:r>
                      <a:rPr lang="it-IT" sz="1000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old</a:t>
                    </a:r>
                    <a:r>
                      <a:rPr lang="it-IT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it-IT" sz="1000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hange</a:t>
                    </a:r>
                    <a:r>
                      <a:rPr lang="it-IT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of control)</a:t>
                    </a:r>
                    <a:endParaRPr lang="it-IT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5" name="Rettangolo 74"/>
                  <p:cNvSpPr/>
                  <p:nvPr/>
                </p:nvSpPr>
                <p:spPr>
                  <a:xfrm>
                    <a:off x="1212684" y="2422332"/>
                    <a:ext cx="489857" cy="152400"/>
                  </a:xfrm>
                  <a:prstGeom prst="rect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</p:grpSp>
            <p:sp>
              <p:nvSpPr>
                <p:cNvPr id="28" name="CasellaDiTesto 27"/>
                <p:cNvSpPr txBox="1"/>
                <p:nvPr/>
              </p:nvSpPr>
              <p:spPr>
                <a:xfrm>
                  <a:off x="2129297" y="916931"/>
                  <a:ext cx="303288" cy="276999"/>
                </a:xfrm>
                <a:prstGeom prst="rect">
                  <a:avLst/>
                </a:prstGeom>
                <a:grp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lang="it-IT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" name="Gruppo 1"/>
              <p:cNvGrpSpPr/>
              <p:nvPr/>
            </p:nvGrpSpPr>
            <p:grpSpPr>
              <a:xfrm>
                <a:off x="2225097" y="417337"/>
                <a:ext cx="1229131" cy="461375"/>
                <a:chOff x="3196118" y="515733"/>
                <a:chExt cx="1229131" cy="461375"/>
              </a:xfrm>
            </p:grpSpPr>
            <p:sp>
              <p:nvSpPr>
                <p:cNvPr id="119" name="Rettangolo 118"/>
                <p:cNvSpPr/>
                <p:nvPr/>
              </p:nvSpPr>
              <p:spPr>
                <a:xfrm>
                  <a:off x="3196118" y="604464"/>
                  <a:ext cx="72000" cy="72000"/>
                </a:xfrm>
                <a:prstGeom prst="rect">
                  <a:avLst/>
                </a:prstGeom>
                <a:solidFill>
                  <a:srgbClr val="5F5F5F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20" name="CasellaDiTesto 119"/>
                <p:cNvSpPr txBox="1"/>
                <p:nvPr/>
              </p:nvSpPr>
              <p:spPr>
                <a:xfrm>
                  <a:off x="3243643" y="515733"/>
                  <a:ext cx="39466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5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trl</a:t>
                  </a:r>
                  <a:endParaRPr lang="it-IT" sz="105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" name="Rettangolo 120"/>
                <p:cNvSpPr/>
                <p:nvPr/>
              </p:nvSpPr>
              <p:spPr>
                <a:xfrm>
                  <a:off x="3196118" y="813565"/>
                  <a:ext cx="72000" cy="72000"/>
                </a:xfrm>
                <a:prstGeom prst="rect">
                  <a:avLst/>
                </a:prstGeom>
                <a:solidFill>
                  <a:srgbClr val="D0CECE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22" name="CasellaDiTesto 121"/>
                <p:cNvSpPr txBox="1"/>
                <p:nvPr/>
              </p:nvSpPr>
              <p:spPr>
                <a:xfrm>
                  <a:off x="3248324" y="723192"/>
                  <a:ext cx="1176925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5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urcumin</a:t>
                  </a:r>
                  <a:r>
                    <a:rPr lang="it-IT" sz="105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20 µM</a:t>
                  </a:r>
                  <a:endParaRPr lang="it-IT" sz="105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24" name="Rettangolo 123"/>
              <p:cNvSpPr/>
              <p:nvPr/>
            </p:nvSpPr>
            <p:spPr>
              <a:xfrm>
                <a:off x="1574586" y="2711576"/>
                <a:ext cx="406817" cy="12532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6846840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418</TotalTime>
  <Words>348</Words>
  <Application>Microsoft Office PowerPoint</Application>
  <PresentationFormat>Widescreen</PresentationFormat>
  <Paragraphs>37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ontana</dc:creator>
  <cp:lastModifiedBy>Fontana</cp:lastModifiedBy>
  <cp:revision>49</cp:revision>
  <cp:lastPrinted>2018-06-22T10:46:44Z</cp:lastPrinted>
  <dcterms:created xsi:type="dcterms:W3CDTF">2018-01-29T17:43:15Z</dcterms:created>
  <dcterms:modified xsi:type="dcterms:W3CDTF">2018-06-22T10:47:17Z</dcterms:modified>
</cp:coreProperties>
</file>